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E22C8"/>
    <a:srgbClr val="FF0000"/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8265" autoAdjust="0"/>
  </p:normalViewPr>
  <p:slideViewPr>
    <p:cSldViewPr snapToGrid="0">
      <p:cViewPr varScale="1">
        <p:scale>
          <a:sx n="89" d="100"/>
          <a:sy n="89" d="100"/>
        </p:scale>
        <p:origin x="13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A38343-5C1D-4666-99BE-18DE4B8E2611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768E85-79F9-4434-BDAC-DDC9A6312C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495327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768E85-79F9-4434-BDAC-DDC9A6312C71}" type="slidenum">
              <a:rPr lang="ru-RU" smtClean="0"/>
              <a:t>1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10146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08187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2857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03187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013385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30493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53637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52745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71916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56919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13650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65607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A8A4C1-9D6E-455B-9D77-525A1EF13F99}" type="datetimeFigureOut">
              <a:rPr lang="ru-RU" smtClean="0"/>
              <a:t>24.07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7D1ABA-F3DE-4A6B-ABA2-1F041D1A577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58094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TextBox 137">
            <a:extLst>
              <a:ext uri="{FF2B5EF4-FFF2-40B4-BE49-F238E27FC236}">
                <a16:creationId xmlns:a16="http://schemas.microsoft.com/office/drawing/2014/main" id="{1A239D79-E5FC-301B-4CCA-A3DCF20EF7D8}"/>
              </a:ext>
            </a:extLst>
          </p:cNvPr>
          <p:cNvSpPr txBox="1"/>
          <p:nvPr/>
        </p:nvSpPr>
        <p:spPr>
          <a:xfrm>
            <a:off x="663939" y="5697995"/>
            <a:ext cx="1111715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Figure S2. </a:t>
            </a: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 of measured (x-axis) and predicted (y-axis) </a:t>
            </a:r>
            <a:r>
              <a:rPr lang="en-US" sz="1800" kern="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Tase</a:t>
            </a: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ctivity for 47 Taq pol variants. A series of experimental validation is marked with color. Each graph shows Spearman's correlation coefficient.</a:t>
            </a:r>
            <a:endParaRPr lang="ru-RU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40" name="Рисунок 139">
            <a:extLst>
              <a:ext uri="{FF2B5EF4-FFF2-40B4-BE49-F238E27FC236}">
                <a16:creationId xmlns:a16="http://schemas.microsoft.com/office/drawing/2014/main" id="{F0FB819D-C20A-DD9C-7564-B97CDFC04DD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338" y="462589"/>
            <a:ext cx="8228059" cy="5117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2786961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</TotalTime>
  <Words>40</Words>
  <Application>Microsoft Office PowerPoint</Application>
  <PresentationFormat>Широкоэкранный</PresentationFormat>
  <Paragraphs>2</Paragraphs>
  <Slides>1</Slides>
  <Notes>1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Company>Vector-Be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Иванов Михаил Константинович</dc:creator>
  <cp:lastModifiedBy>Denis Antonets</cp:lastModifiedBy>
  <cp:revision>51</cp:revision>
  <dcterms:created xsi:type="dcterms:W3CDTF">2024-06-09T09:30:34Z</dcterms:created>
  <dcterms:modified xsi:type="dcterms:W3CDTF">2024-07-24T10:34:52Z</dcterms:modified>
</cp:coreProperties>
</file>